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A088C6-0BA7-4E9F-8C5B-1D043672BC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30D368-B481-4EA7-815A-AA9F77EC97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68FD73-7C94-404F-A099-D8F64CA36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750F51-A1AE-495A-BA75-237177A64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21F9FA-77F6-4836-BAD9-8B0EAB21F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068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EDCB04-EE32-4D7F-A08C-EBC02D39B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3B1C5A-95B0-44FF-A26A-CB219D6853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0065B9-EBA4-4910-8C33-109CE18A1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C3D7EB-2629-43AA-9F62-BDB911AC9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42E438-A191-4795-9D39-95A06217A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74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5FC792-1305-497F-AADC-31E0DD173B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4C0128-D1BB-4481-89A0-C56D019542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90C3E4-2F5D-4463-BF89-12ED2BD86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E79D68-227F-4EC6-B20C-DC18AE697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F7769D-12E9-4A7E-8999-66FA7F45F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437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6F3AB-A8F9-4A49-B8FB-308A1DAE7D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88CA88-E340-4C8F-B89A-F9043203BA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BB85F-50DF-4476-8FB8-3E1CF6DFC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E2968B-5BA6-4823-B3D8-2763D7A2F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C18369-B577-498A-952B-04E3C99B7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9019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C7DBF3-D70D-4997-8A9F-2B4AEE084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FFCDE5-AE25-4E3F-B870-ECA6936A1F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60979F-D211-41F1-88C1-36EF10C78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1A53D-ACD8-4253-8577-9FB98A3B9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3798B7-6645-4EB7-A852-B921A7993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495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9CBBC9-03E9-44AF-B67C-1659BC32A4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45E736-C59A-4DDF-9E82-0F9921D713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89821C-3400-4725-9074-3325F50BEB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FDB75B-9AA8-47CB-9467-E39553790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A8C563-48FD-435E-A877-F2935FC0B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13334A-7803-43B8-98F7-E84633B78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9646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AEC93-5AC1-4E3C-BA68-C046A9B33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E0D948-24D5-4058-B434-8113EE69D8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73E32A-BB0B-46DF-A9BF-4099340C57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4FB2C55-FAC1-456F-B20B-2092CB24D2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BD6C42-D362-4357-B819-763491A13C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034C5B-DBA5-48F2-BA75-16417F571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0A531B-4C71-4C35-9295-E8F2849A4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01EEDC-F0C5-4B52-A203-8625F9130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0874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A28BA-8796-4AE6-A18A-7018916B2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8501AB-6FD3-49AC-9D24-CC5124C87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98B9F0-0254-4711-8798-D831DA747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5F91F5-9E37-4F87-ABE9-23AC6B33B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0300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CBDFD5-F905-4C4F-99BA-924250884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5E0A5F-EF9C-474A-BCDA-4DE0F832F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523818D-E566-4FA9-88DE-E0543E567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717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AF6667-533F-4597-A2A9-601B97F95A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724825-B8A6-4D10-9404-7AE2F6001D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E89435-EF02-4A09-84EF-BD2CD7A965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8BAAD0-3A93-427A-A932-F14F3E2EB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27201E-1C9D-4A59-B40E-5A4B8BC9C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ED825B-3842-4713-9351-4D9E87BB5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3692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6E0F28-B3A8-4361-9E7C-D213465D5E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13DF74-FCDF-45F4-AE83-F2EEDEB5F8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2D4F4D-F88F-4656-933A-6FD453E710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FEE020-05DA-49CE-8247-A17A55843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475194-B712-4312-9134-371FFE881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B76ACD-ED9B-49F4-997A-9414D3967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0231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01E796-FDA0-44B3-B8B1-B01B621956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A210C2-9673-4360-BBE8-03BBB83C9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2DC64-453B-419B-9CC4-01AABD0DD2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A5F3B-7EA8-43D4-8ABB-9F48F21ACEAA}" type="datetimeFigureOut">
              <a:rPr lang="en-GB" smtClean="0"/>
              <a:t>22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6F10EE-1CDB-4CBE-887F-CA63B39323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A293AC-F428-4A11-ADA2-E5C75F170A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0D9677-A496-496A-9A89-9717EC816E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520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98">
            <a:extLst>
              <a:ext uri="{FF2B5EF4-FFF2-40B4-BE49-F238E27FC236}">
                <a16:creationId xmlns:a16="http://schemas.microsoft.com/office/drawing/2014/main" id="{3FA9C7F3-E8AA-433A-93F6-FA3296635052}"/>
              </a:ext>
            </a:extLst>
          </p:cNvPr>
          <p:cNvSpPr txBox="1"/>
          <p:nvPr/>
        </p:nvSpPr>
        <p:spPr>
          <a:xfrm>
            <a:off x="9273767" y="763455"/>
            <a:ext cx="1947146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00" dirty="0"/>
              <a:t>DAPC</a:t>
            </a:r>
            <a:r>
              <a:rPr lang="en-GB" sz="1950" b="1" dirty="0"/>
              <a:t>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A9746BA7-CE3D-48A1-9A00-B1A0DCF3F11F}"/>
              </a:ext>
            </a:extLst>
          </p:cNvPr>
          <p:cNvGrpSpPr/>
          <p:nvPr/>
        </p:nvGrpSpPr>
        <p:grpSpPr>
          <a:xfrm>
            <a:off x="2175378" y="892443"/>
            <a:ext cx="7841243" cy="5516466"/>
            <a:chOff x="1422400" y="49175"/>
            <a:chExt cx="9650761" cy="6789497"/>
          </a:xfrm>
        </p:grpSpPr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0B27BAE1-A66B-4AAE-AA13-7731200197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05095" y="204145"/>
              <a:ext cx="3191366" cy="3168000"/>
            </a:xfrm>
            <a:prstGeom prst="rect">
              <a:avLst/>
            </a:prstGeom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84CAFF2E-9C4D-49C1-A77D-7DCD8A77821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056040" y="204145"/>
              <a:ext cx="3163378" cy="3168000"/>
            </a:xfrm>
            <a:prstGeom prst="rect">
              <a:avLst/>
            </a:prstGeom>
          </p:spPr>
        </p:pic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DA75DDFC-91D1-4D9B-B918-7B1AEFA9DB10}"/>
                </a:ext>
              </a:extLst>
            </p:cNvPr>
            <p:cNvSpPr txBox="1"/>
            <p:nvPr/>
          </p:nvSpPr>
          <p:spPr>
            <a:xfrm>
              <a:off x="1494471" y="3046872"/>
              <a:ext cx="2396487" cy="3598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300" dirty="0"/>
                <a:t>K=3</a:t>
              </a:r>
            </a:p>
          </p:txBody>
        </p:sp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BD4F4E5D-B83E-4D9D-B6B6-F27904D9482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76461" y="3610345"/>
              <a:ext cx="3420000" cy="3168000"/>
            </a:xfrm>
            <a:prstGeom prst="rect">
              <a:avLst/>
            </a:prstGeom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18CA3D72-FA2E-426F-9298-C925C1D2D9DC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012778" y="3600185"/>
              <a:ext cx="3420000" cy="3168000"/>
            </a:xfrm>
            <a:prstGeom prst="rect">
              <a:avLst/>
            </a:prstGeom>
          </p:spPr>
        </p:pic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F23A9889-BAC8-4739-A0FC-7E555FAB4ECF}"/>
                </a:ext>
              </a:extLst>
            </p:cNvPr>
            <p:cNvSpPr txBox="1"/>
            <p:nvPr/>
          </p:nvSpPr>
          <p:spPr>
            <a:xfrm>
              <a:off x="1566389" y="204145"/>
              <a:ext cx="2396487" cy="4214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300" dirty="0"/>
                <a:t>STRUCTURE</a:t>
              </a:r>
              <a:r>
                <a:rPr lang="en-GB" sz="1625" dirty="0"/>
                <a:t> 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42837FC1-226B-4736-A39E-9DC7B5353E24}"/>
                </a:ext>
              </a:extLst>
            </p:cNvPr>
            <p:cNvSpPr txBox="1"/>
            <p:nvPr/>
          </p:nvSpPr>
          <p:spPr>
            <a:xfrm>
              <a:off x="1494471" y="6398853"/>
              <a:ext cx="2396487" cy="3598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300" dirty="0"/>
                <a:t>K=6</a:t>
              </a:r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2AEB41CF-158A-4F24-ADEA-2466FE3E43F9}"/>
                </a:ext>
              </a:extLst>
            </p:cNvPr>
            <p:cNvSpPr/>
            <p:nvPr/>
          </p:nvSpPr>
          <p:spPr>
            <a:xfrm>
              <a:off x="1422400" y="49175"/>
              <a:ext cx="9650761" cy="6778345"/>
            </a:xfrm>
            <a:prstGeom prst="rect">
              <a:avLst/>
            </a:prstGeom>
            <a:noFill/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463"/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163D643B-B292-4E33-A2D2-1E212960FA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649225" y="60327"/>
              <a:ext cx="0" cy="6778345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BA0E5CA4-A639-447A-BE6D-F66344EEB06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249161" y="-1351425"/>
              <a:ext cx="0" cy="9648000"/>
            </a:xfrm>
            <a:prstGeom prst="line">
              <a:avLst/>
            </a:prstGeom>
            <a:ln w="3175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D47C5924-9421-4424-B9D9-1885C9624A5A}"/>
              </a:ext>
            </a:extLst>
          </p:cNvPr>
          <p:cNvSpPr txBox="1"/>
          <p:nvPr/>
        </p:nvSpPr>
        <p:spPr>
          <a:xfrm>
            <a:off x="627541" y="398154"/>
            <a:ext cx="86462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5 Figure   </a:t>
            </a:r>
            <a:r>
              <a:rPr lang="en-GB" sz="1600" dirty="0"/>
              <a:t>Concordance between cluster assignment in STRUCTURE and DAPC</a:t>
            </a:r>
          </a:p>
        </p:txBody>
      </p:sp>
    </p:spTree>
    <p:extLst>
      <p:ext uri="{BB962C8B-B14F-4D97-AF65-F5344CB8AC3E}">
        <p14:creationId xmlns:p14="http://schemas.microsoft.com/office/powerpoint/2010/main" val="3506964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0</TotalTime>
  <Words>18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Ball</dc:creator>
  <cp:lastModifiedBy>Sarah Ball</cp:lastModifiedBy>
  <cp:revision>9</cp:revision>
  <dcterms:created xsi:type="dcterms:W3CDTF">2019-11-20T10:51:18Z</dcterms:created>
  <dcterms:modified xsi:type="dcterms:W3CDTF">2020-03-22T17:04:16Z</dcterms:modified>
</cp:coreProperties>
</file>